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0E8BA0-D243-42D3-BA18-1C9AF657C55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D29B09-272A-4B5B-A282-097C12523D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E229C2-A13D-4C29-928A-E070135D810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146313-C712-4794-9696-6ADFD7133B4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DC6DFE-6EBA-4E90-AD88-88C9417D3E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5E0762-D9C7-4208-81B5-808FA6DFE24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830093-E6D8-4325-ABA4-AB04FD33E4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B731DB-91BC-440C-8286-FDF880C35C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41001F-0431-4946-A620-90AC097B74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6CA6E6-CD7F-4B06-8090-89138CE7F5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02916A-B592-4F8B-BD02-A2B378CA98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58C5BA-D1BD-4CB6-B4EE-9F8101998A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3B006D0-7994-4503-9AAC-DD979C2277F3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hteck 5"/>
          <p:cNvSpPr/>
          <p:nvPr/>
        </p:nvSpPr>
        <p:spPr>
          <a:xfrm>
            <a:off x="2330280" y="1028880"/>
            <a:ext cx="2035440" cy="230040"/>
          </a:xfrm>
          <a:prstGeom prst="rect">
            <a:avLst/>
          </a:prstGeom>
          <a:solidFill>
            <a:srgbClr val="92d05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feld 4"/>
          <p:cNvSpPr/>
          <p:nvPr/>
        </p:nvSpPr>
        <p:spPr>
          <a:xfrm>
            <a:off x="0" y="611280"/>
            <a:ext cx="6813720" cy="3561840"/>
          </a:xfrm>
          <a:prstGeom prst="rect">
            <a:avLst/>
          </a:prstGeom>
          <a:noFill/>
          <a:ln w="93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human 1 mrlliltclvavalarpklplry...perlqnpsess...epiplesree 4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   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|:|||||||||||||||| |:::   |: . | .       | |    .|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bovine 1 mklliltclvavalarpkhpikhqglpqevlnenllrffvapfpevfgke 5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            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.         .         .         .         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45 ymngmnrq..rnilrekqtdeikdtrnestqncvvaepekmessisssse 9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    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.| :.:        :.  ::||    ||  .     |  .|       :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51 kvnelskdigsestedqamedikqmeaesissseeivpnsveqkhiqked 1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            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.         .         .         .         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93 emslskca..eqfcrlneyn..qlqlqaahaqeqirrmnenshvq..... 13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     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|       ||  || .|   ||::    |:|.:  | |  | |   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101 vpserylgyleqllrlkkykvpqleivpnsaeerlhsmkegihaqqkepm 15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            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.         .         .         .         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</a:t>
            </a:r>
            <a:r>
              <a:rPr b="1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134 ..........vp..fqqlnqlaaypyavwyy.pqimqyvpfppfsdisnp 17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              </a:t>
            </a:r>
            <a:r>
              <a:rPr b="1" lang="de-DE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|  |.|  || |||   ||| |   ||   | |||| ||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</a:t>
            </a:r>
            <a:r>
              <a:rPr b="1" lang="de-DE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151 igvnqelayfypelfrqfyqldaypsgawyyvplgtqytdapsfsdipnp 2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            </a:t>
            </a:r>
            <a:r>
              <a:rPr b="1" lang="de-DE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.   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</a:t>
            </a:r>
            <a:r>
              <a:rPr b="1" lang="de-DE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171 tahenyeknnvmlqw 18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      </a:t>
            </a:r>
            <a:r>
              <a:rPr b="1" lang="de-DE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|| ||  . | |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</a:t>
            </a:r>
            <a:r>
              <a:rPr b="1" lang="de-DE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201 igsensekttmpl.w 21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feld 8"/>
          <p:cNvSpPr/>
          <p:nvPr/>
        </p:nvSpPr>
        <p:spPr>
          <a:xfrm>
            <a:off x="0" y="0"/>
            <a:ext cx="609300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Calibri"/>
              </a:rPr>
              <a:t>Supporting  Fig. S3: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7-20T11:47:31Z</dcterms:created>
  <dc:creator>Jose</dc:creator>
  <dc:description/>
  <dc:language>en-US</dc:language>
  <cp:lastModifiedBy>seklumpp</cp:lastModifiedBy>
  <dcterms:modified xsi:type="dcterms:W3CDTF">2011-10-20T06:37:59Z</dcterms:modified>
  <cp:revision>15</cp:revision>
  <dc:subject/>
  <dc:title>Folie 1</dc:title>
</cp:coreProperties>
</file>